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2D334-4657-4EFC-AA60-FCABF298EE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4142B1-2650-4C0D-BA2D-7A650D01BE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46093-EFCE-46E0-BB80-A48873239B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7E35C-6840-422B-A28A-B4D52FB97F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55435-83BA-4032-A8E6-478B4F0DF3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5FFC4-8D22-4D26-A4DA-A8DFDBD45E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17B97-45BF-4984-9418-301F086FD6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2E55A5-4BCB-417E-89C6-4733CB0E14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BA1DA-397C-403B-92C6-604D441998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5FE0E-F8EF-4B93-8BE3-B7A945BA11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9FE1B4-CCED-48BE-8595-56FCA77E71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570C7-17BD-4303-B745-9E568DE0EA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2830EE-972B-4B8B-ABCB-F8881E3D34EB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703440" y="1320840"/>
            <a:ext cx="10432800" cy="4257360"/>
            <a:chOff x="703440" y="1320840"/>
            <a:chExt cx="10432800" cy="4257360"/>
          </a:xfrm>
        </p:grpSpPr>
        <p:grpSp>
          <p:nvGrpSpPr>
            <p:cNvPr id="42" name="Gruppo 14"/>
            <p:cNvGrpSpPr/>
            <p:nvPr/>
          </p:nvGrpSpPr>
          <p:grpSpPr>
            <a:xfrm>
              <a:off x="703440" y="1320840"/>
              <a:ext cx="10432800" cy="4257360"/>
              <a:chOff x="703440" y="1320840"/>
              <a:chExt cx="10432800" cy="4257360"/>
            </a:xfrm>
          </p:grpSpPr>
          <p:pic>
            <p:nvPicPr>
              <p:cNvPr id="43" name="Immagin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043280" y="1951920"/>
                <a:ext cx="3131640" cy="3288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CasellaDiTesto 2"/>
              <p:cNvSpPr/>
              <p:nvPr/>
            </p:nvSpPr>
            <p:spPr>
              <a:xfrm>
                <a:off x="1530000" y="1433520"/>
                <a:ext cx="96062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  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ealthy control                           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	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    Sibling (HSCT donor)             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	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	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atient 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45" name="Immagine 3" descr=""/>
              <p:cNvPicPr/>
              <p:nvPr/>
            </p:nvPicPr>
            <p:blipFill>
              <a:blip r:embed="rId2"/>
              <a:stretch/>
            </p:blipFill>
            <p:spPr>
              <a:xfrm>
                <a:off x="4174920" y="1970280"/>
                <a:ext cx="3076560" cy="3251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Immagine 5" descr=""/>
              <p:cNvPicPr/>
              <p:nvPr/>
            </p:nvPicPr>
            <p:blipFill>
              <a:blip r:embed="rId3"/>
              <a:stretch/>
            </p:blipFill>
            <p:spPr>
              <a:xfrm>
                <a:off x="7552800" y="1970280"/>
                <a:ext cx="3208680" cy="3270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CasellaDiTesto 6"/>
              <p:cNvSpPr/>
              <p:nvPr/>
            </p:nvSpPr>
            <p:spPr>
              <a:xfrm>
                <a:off x="1441800" y="2103840"/>
                <a:ext cx="30340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,8%CD4+FoxP3+CD25+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reg/CD4+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CasellaDiTesto 7"/>
              <p:cNvSpPr/>
              <p:nvPr/>
            </p:nvSpPr>
            <p:spPr>
              <a:xfrm>
                <a:off x="4573440" y="2103840"/>
                <a:ext cx="29350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,2%CD4+FoxP3+CD25+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reg/CD4+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CasellaDiTesto 8"/>
              <p:cNvSpPr/>
              <p:nvPr/>
            </p:nvSpPr>
            <p:spPr>
              <a:xfrm>
                <a:off x="7932240" y="2087640"/>
                <a:ext cx="30150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,3%CD4+FoxP3+CD25+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reg/CD4+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CasellaDiTesto 9"/>
              <p:cNvSpPr/>
              <p:nvPr/>
            </p:nvSpPr>
            <p:spPr>
              <a:xfrm rot="16200000">
                <a:off x="-1244160" y="3268440"/>
                <a:ext cx="42328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D25 PE-Cy7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CasellaDiTesto 10"/>
              <p:cNvSpPr/>
              <p:nvPr/>
            </p:nvSpPr>
            <p:spPr>
              <a:xfrm>
                <a:off x="1732680" y="5240880"/>
                <a:ext cx="21027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oxP3 PE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52" name="Connettore 2 12"/>
              <p:cNvCxnSpPr/>
              <p:nvPr/>
            </p:nvCxnSpPr>
            <p:spPr>
              <a:xfrm>
                <a:off x="3444840" y="5546520"/>
                <a:ext cx="6466320" cy="1080"/>
              </a:xfrm>
              <a:prstGeom prst="straightConnector1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sp>
          <p:nvSpPr>
            <p:cNvPr id="53" name="TextBox 1"/>
            <p:cNvSpPr/>
            <p:nvPr/>
          </p:nvSpPr>
          <p:spPr>
            <a:xfrm>
              <a:off x="716760" y="1649880"/>
              <a:ext cx="391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"/>
            <p:cNvSpPr/>
            <p:nvPr/>
          </p:nvSpPr>
          <p:spPr>
            <a:xfrm>
              <a:off x="4087800" y="1713240"/>
              <a:ext cx="400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3"/>
            <p:cNvSpPr/>
            <p:nvPr/>
          </p:nvSpPr>
          <p:spPr>
            <a:xfrm>
              <a:off x="7381800" y="1713240"/>
              <a:ext cx="300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6" name="CasellaDiTesto 1"/>
          <p:cNvSpPr/>
          <p:nvPr/>
        </p:nvSpPr>
        <p:spPr>
          <a:xfrm>
            <a:off x="703440" y="5900760"/>
            <a:ext cx="97977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henotypic characterization of CD4+FoxP3+CD25high Treg lymphocytes. The plots show the phenotypic analysis  of CD4+FoxP3+CD25high Treg lymphocytes performed on PBMC derived from healthy control (Panel A), sibling-HSCT donor (Panel B) and our patient (Panel C), respectively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2-16T22:13:53Z</dcterms:created>
  <dc:creator>Admin</dc:creator>
  <dc:description/>
  <dc:language>en-US</dc:language>
  <cp:lastModifiedBy>Edoardo La Porta</cp:lastModifiedBy>
  <dcterms:modified xsi:type="dcterms:W3CDTF">2022-02-22T14:36:40Z</dcterms:modified>
  <cp:revision>6</cp:revision>
  <dc:subject/>
  <dc:title>PowerPoint Presentation</dc:title>
</cp:coreProperties>
</file>